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ommentAuthors.xml" ContentType="application/vnd.openxmlformats-officedocument.presentationml.commentAuthors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1" r:id="rId2"/>
  </p:sldIdLst>
  <p:sldSz cx="6858000" cy="9144000" type="letter"/>
  <p:notesSz cx="7099300" cy="1023461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aryse" initials="M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clrMru>
    <a:srgbClr val="007DDA"/>
    <a:srgbClr val="FF9953"/>
    <a:srgbClr val="04481B"/>
    <a:srgbClr val="056726"/>
    <a:srgbClr val="079D39"/>
    <a:srgbClr val="00FF00"/>
    <a:srgbClr val="FF6600"/>
    <a:srgbClr val="CC3300"/>
    <a:srgbClr val="F9D6B9"/>
    <a:srgbClr val="F38E07"/>
  </p:clrMru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SorterView">
  <p:normalViewPr snapVertSplitter="1" vertBarState="minimized" horzBarState="maximized">
    <p:restoredLeft sz="15620"/>
    <p:restoredTop sz="94660"/>
  </p:normalViewPr>
  <p:slideViewPr>
    <p:cSldViewPr>
      <p:cViewPr>
        <p:scale>
          <a:sx n="100" d="100"/>
          <a:sy n="100" d="100"/>
        </p:scale>
        <p:origin x="-1614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86B7BD-CC48-42E3-8A47-310894B29D10}" type="datetimeFigureOut">
              <a:rPr lang="en-CA" smtClean="0"/>
              <a:pPr/>
              <a:t>10/05/2012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9461D1-C685-4FFE-BDBF-FD70351299D2}" type="slidenum">
              <a:rPr lang="en-CA" smtClean="0"/>
              <a:pPr/>
              <a:t>‹N°›</a:t>
            </a:fld>
            <a:endParaRPr lang="en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1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600" y="1115568"/>
            <a:ext cx="2971800" cy="24060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3581400" y="1496568"/>
            <a:ext cx="2514600" cy="19126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0" name="TextBox 39"/>
          <p:cNvSpPr txBox="1"/>
          <p:nvPr/>
        </p:nvSpPr>
        <p:spPr>
          <a:xfrm>
            <a:off x="151551" y="1081814"/>
            <a:ext cx="61044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CA" sz="1600" b="1" dirty="0">
              <a:solidFill>
                <a:schemeClr val="accent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39"/>
          <p:cNvSpPr txBox="1"/>
          <p:nvPr/>
        </p:nvSpPr>
        <p:spPr>
          <a:xfrm>
            <a:off x="257300" y="3487859"/>
            <a:ext cx="4285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CA" sz="1600" b="1" dirty="0">
              <a:solidFill>
                <a:schemeClr val="accent6"/>
              </a:solidFill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Rectangle 11"/>
          <p:cNvSpPr/>
          <p:nvPr/>
        </p:nvSpPr>
        <p:spPr>
          <a:xfrm>
            <a:off x="3416629" y="1142880"/>
            <a:ext cx="152400" cy="152400"/>
          </a:xfrm>
          <a:prstGeom prst="rect">
            <a:avLst/>
          </a:prstGeom>
          <a:solidFill>
            <a:srgbClr val="00FF00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3" name="Rectangle 12"/>
          <p:cNvSpPr/>
          <p:nvPr/>
        </p:nvSpPr>
        <p:spPr>
          <a:xfrm>
            <a:off x="2133600" y="1142880"/>
            <a:ext cx="152400" cy="152400"/>
          </a:xfrm>
          <a:prstGeom prst="rect">
            <a:avLst/>
          </a:prstGeom>
          <a:solidFill>
            <a:schemeClr val="tx2">
              <a:lumMod val="60000"/>
              <a:lumOff val="4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 sz="900"/>
          </a:p>
        </p:txBody>
      </p:sp>
      <p:sp>
        <p:nvSpPr>
          <p:cNvPr id="14" name="ZoneTexte 158"/>
          <p:cNvSpPr txBox="1"/>
          <p:nvPr/>
        </p:nvSpPr>
        <p:spPr>
          <a:xfrm>
            <a:off x="2264446" y="1115568"/>
            <a:ext cx="108234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smtClean="0">
                <a:latin typeface="Arial" pitchFamily="34" charset="0"/>
                <a:cs typeface="Arial" pitchFamily="34" charset="0"/>
              </a:rPr>
              <a:t>Polar interactions</a:t>
            </a:r>
            <a:endParaRPr lang="fr-FR" sz="9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ZoneTexte 159"/>
          <p:cNvSpPr txBox="1"/>
          <p:nvPr/>
        </p:nvSpPr>
        <p:spPr>
          <a:xfrm>
            <a:off x="3528668" y="1117002"/>
            <a:ext cx="14542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Arial" pitchFamily="34" charset="0"/>
                <a:cs typeface="Arial" pitchFamily="34" charset="0"/>
              </a:rPr>
              <a:t>Hydrophobic</a:t>
            </a:r>
            <a:r>
              <a:rPr lang="fr-FR" sz="900" dirty="0" smtClean="0">
                <a:latin typeface="Arial" pitchFamily="34" charset="0"/>
                <a:cs typeface="Arial" pitchFamily="34" charset="0"/>
              </a:rPr>
              <a:t> interactions</a:t>
            </a:r>
            <a:endParaRPr lang="fr-FR" sz="9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6" name="Straight Connector 15"/>
          <p:cNvCxnSpPr/>
          <p:nvPr/>
        </p:nvCxnSpPr>
        <p:spPr>
          <a:xfrm>
            <a:off x="3412200" y="1496568"/>
            <a:ext cx="0" cy="175260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Curved Up Arrow 16"/>
          <p:cNvSpPr/>
          <p:nvPr/>
        </p:nvSpPr>
        <p:spPr>
          <a:xfrm>
            <a:off x="3315600" y="2258568"/>
            <a:ext cx="228600" cy="121920"/>
          </a:xfrm>
          <a:prstGeom prst="curvedUpArrow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CA">
              <a:solidFill>
                <a:schemeClr val="tx1"/>
              </a:solidFill>
            </a:endParaRPr>
          </a:p>
        </p:txBody>
      </p:sp>
      <p:grpSp>
        <p:nvGrpSpPr>
          <p:cNvPr id="18" name="Group 17"/>
          <p:cNvGrpSpPr/>
          <p:nvPr/>
        </p:nvGrpSpPr>
        <p:grpSpPr>
          <a:xfrm>
            <a:off x="3214800" y="2373168"/>
            <a:ext cx="418704" cy="230832"/>
            <a:chOff x="4588800" y="6511200"/>
            <a:chExt cx="418704" cy="230832"/>
          </a:xfrm>
        </p:grpSpPr>
        <p:sp>
          <p:nvSpPr>
            <p:cNvPr id="19" name="Rectangle 18"/>
            <p:cNvSpPr/>
            <p:nvPr/>
          </p:nvSpPr>
          <p:spPr>
            <a:xfrm>
              <a:off x="4648200" y="6549000"/>
              <a:ext cx="304800" cy="156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CA"/>
            </a:p>
          </p:txBody>
        </p:sp>
        <p:sp>
          <p:nvSpPr>
            <p:cNvPr id="20" name="ZoneTexte 99"/>
            <p:cNvSpPr txBox="1"/>
            <p:nvPr/>
          </p:nvSpPr>
          <p:spPr>
            <a:xfrm>
              <a:off x="4588800" y="6511200"/>
              <a:ext cx="41870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900" dirty="0" smtClean="0">
                  <a:latin typeface="Arial" pitchFamily="34" charset="0"/>
                  <a:cs typeface="Arial" pitchFamily="34" charset="0"/>
                </a:rPr>
                <a:t>180º</a:t>
              </a:r>
              <a:endParaRPr lang="fr-FR" sz="900" dirty="0">
                <a:latin typeface="Arial" pitchFamily="34" charset="0"/>
                <a:cs typeface="Arial" pitchFamily="34" charset="0"/>
              </a:endParaRPr>
            </a:p>
          </p:txBody>
        </p:sp>
      </p:grpSp>
      <p:graphicFrame>
        <p:nvGraphicFramePr>
          <p:cNvPr id="21" name="Table 20"/>
          <p:cNvGraphicFramePr>
            <a:graphicFrameLocks noGrp="1"/>
          </p:cNvGraphicFramePr>
          <p:nvPr/>
        </p:nvGraphicFramePr>
        <p:xfrm>
          <a:off x="914400" y="3553968"/>
          <a:ext cx="4953001" cy="4751832"/>
        </p:xfrm>
        <a:graphic>
          <a:graphicData uri="http://schemas.openxmlformats.org/drawingml/2006/table">
            <a:tbl>
              <a:tblPr firstRow="1" bandRow="1">
                <a:tableStyleId>{9D7B26C5-4107-4FEC-AEDC-1716B250A1EF}</a:tableStyleId>
              </a:tblPr>
              <a:tblGrid>
                <a:gridCol w="893045"/>
                <a:gridCol w="806970"/>
                <a:gridCol w="602539"/>
                <a:gridCol w="699373"/>
                <a:gridCol w="624057"/>
                <a:gridCol w="699373"/>
                <a:gridCol w="627644"/>
              </a:tblGrid>
              <a:tr h="155448"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Hydrogen</a:t>
                      </a:r>
                      <a:r>
                        <a:rPr lang="en-US" sz="8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bonds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A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  <a:alpha val="2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A" sz="10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  <a:alpha val="20000"/>
                      </a:schemeClr>
                    </a:solidFill>
                  </a:tcPr>
                </a:tc>
                <a:tc gridSpan="4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Buried</a:t>
                      </a:r>
                      <a:r>
                        <a:rPr lang="en-US" sz="8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Surface Area (BSA) of interfacing residues</a:t>
                      </a:r>
                      <a:endParaRPr lang="en-CA" sz="800" baseline="3000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CA" sz="1000" dirty="0" smtClean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50000"/>
                        <a:alpha val="20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CA"/>
                    </a:p>
                  </a:txBody>
                  <a:tcPr/>
                </a:tc>
              </a:tr>
              <a:tr h="243840"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 smtClean="0">
                          <a:latin typeface="Times New Roman" pitchFamily="18" charset="0"/>
                          <a:cs typeface="Times New Roman" pitchFamily="18" charset="0"/>
                        </a:rPr>
                        <a:t>Pf</a:t>
                      </a:r>
                      <a:r>
                        <a:rPr lang="en-US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AMA1</a:t>
                      </a:r>
                      <a:endParaRPr lang="en-CA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i="1" dirty="0" smtClean="0">
                          <a:latin typeface="Times New Roman" pitchFamily="18" charset="0"/>
                          <a:cs typeface="Times New Roman" pitchFamily="18" charset="0"/>
                        </a:rPr>
                        <a:t>Pf</a:t>
                      </a:r>
                      <a:r>
                        <a:rPr lang="en-US" sz="800" b="0" dirty="0" smtClean="0">
                          <a:latin typeface="Times New Roman" pitchFamily="18" charset="0"/>
                          <a:cs typeface="Times New Roman" pitchFamily="18" charset="0"/>
                        </a:rPr>
                        <a:t>RON2sp</a:t>
                      </a:r>
                      <a:endParaRPr lang="en-CA" sz="800" b="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Distance</a:t>
                      </a:r>
                      <a:r>
                        <a:rPr lang="en-US" sz="8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(Å)</a:t>
                      </a:r>
                      <a:endParaRPr lang="en-CA" sz="800" b="1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 smtClean="0">
                          <a:latin typeface="Times New Roman" pitchFamily="18" charset="0"/>
                          <a:cs typeface="Times New Roman" pitchFamily="18" charset="0"/>
                        </a:rPr>
                        <a:t>Pf</a:t>
                      </a:r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MA1</a:t>
                      </a:r>
                      <a:endParaRPr lang="en-CA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BSA</a:t>
                      </a:r>
                      <a:r>
                        <a:rPr lang="en-US" sz="8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(Å</a:t>
                      </a:r>
                      <a:r>
                        <a:rPr lang="en-US" sz="8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8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) &gt;20</a:t>
                      </a:r>
                      <a:endParaRPr lang="en-CA" sz="800" b="1" baseline="0" dirty="0" smtClean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i="1" dirty="0" smtClean="0">
                          <a:latin typeface="Times New Roman" pitchFamily="18" charset="0"/>
                          <a:cs typeface="Times New Roman" pitchFamily="18" charset="0"/>
                        </a:rPr>
                        <a:t>Pf</a:t>
                      </a:r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RON2sp</a:t>
                      </a:r>
                      <a:endParaRPr lang="en-CA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BSA (</a:t>
                      </a:r>
                      <a:r>
                        <a:rPr lang="en-US" sz="8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Å</a:t>
                      </a:r>
                      <a:r>
                        <a:rPr lang="en-US" sz="800" baseline="30000" dirty="0" smtClean="0"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)</a:t>
                      </a:r>
                      <a:r>
                        <a:rPr lang="en-US" sz="800" baseline="0" dirty="0" smtClean="0">
                          <a:latin typeface="Times New Roman" pitchFamily="18" charset="0"/>
                          <a:cs typeface="Times New Roman" pitchFamily="18" charset="0"/>
                        </a:rPr>
                        <a:t> &gt;5</a:t>
                      </a:r>
                      <a:endParaRPr lang="en-CA" sz="800" b="1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rg143 [NH1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p2028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83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Tyr14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67.6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Gln2025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67.7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yr390 [OH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p2028 [O</a:t>
                      </a:r>
                      <a:r>
                        <a:rPr lang="el-GR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δ</a:t>
                      </a:r>
                      <a:r>
                        <a:rPr lang="en-CA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53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rg14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7.5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Lys2027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66.9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la254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ly2030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49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la17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26.1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sp202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70.0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yr251 [OH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o2033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81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Thr171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5.9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Ile2029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122.0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yr251 [OH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la2035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42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Gly17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35.01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Gly203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61.3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p227 [O</a:t>
                      </a:r>
                      <a:r>
                        <a:rPr lang="el-GR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δ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r2036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63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Leu17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3.2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la2031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16.2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p227 [O</a:t>
                      </a:r>
                      <a:r>
                        <a:rPr lang="el-GR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δ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r2036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46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Pro185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38.95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Gly203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21.1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p227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ys2037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06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Thr18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2.2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Pro203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117.3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p227 [O</a:t>
                      </a:r>
                      <a:r>
                        <a:rPr lang="el-GR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δ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ys2037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69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Glu187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38.9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Val2034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22.0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baseline="0" dirty="0" smtClean="0">
                          <a:solidFill>
                            <a:srgbClr val="007DDA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le225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hr2039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78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Pro18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3.5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la2035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31.9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baseline="0" dirty="0" smtClean="0">
                          <a:solidFill>
                            <a:srgbClr val="007DDA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Ile225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hr2039</a:t>
                      </a:r>
                      <a:r>
                        <a:rPr lang="en-US" sz="800" b="0" baseline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10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Phe201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26.87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er203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10.1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n223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rg2041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81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sn205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34.39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Cys2037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29.71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n223 [O</a:t>
                      </a:r>
                      <a:r>
                        <a:rPr lang="el-GR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δ</a:t>
                      </a:r>
                      <a:r>
                        <a:rPr lang="en-CA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rg2041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96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sn22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75.29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Phe203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96.8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ly222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rg2041 [NH1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87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Met224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4.27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Thr2039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0.0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rgbClr val="007DDA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t224 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rg2041 [NH1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34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Ile225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82.05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rg2041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179.4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yr234 [O</a:t>
                      </a:r>
                      <a:r>
                        <a:rPr lang="en-CA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]</a:t>
                      </a:r>
                      <a:endParaRPr lang="en-US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rg2041 [NH1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33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Pro22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33.7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Met204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116.8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Tyr234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rg2041 [NH2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08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sp227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71.8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Gln204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2.04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Ser232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rg2041 [NH2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70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Tyr234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29.4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Gln2047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6.14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n223 [O</a:t>
                      </a:r>
                      <a:r>
                        <a:rPr lang="el-GR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δ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Met2042 [N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84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Lys235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17.49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Ile204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81.3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lu187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ys2049 [O]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97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Tyr251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88.0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Cys2049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24.15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rgbClr val="007DDA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lu187 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Cys2049 [N]</a:t>
                      </a: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25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la254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38.6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Leu205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1.2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rgbClr val="007DDA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lu187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n2051 [O</a:t>
                      </a:r>
                      <a:r>
                        <a:rPr lang="el-GR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δ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53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Tyr26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6.6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Ser205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39.62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Pro185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n2051 [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19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sn271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24.39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Val205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17.59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rgbClr val="007DDA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ly172 </a:t>
                      </a:r>
                      <a:r>
                        <a:rPr lang="en-US" sz="800" b="0" dirty="0" smtClean="0">
                          <a:solidFill>
                            <a:srgbClr val="00B0F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N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Val2053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83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Met273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35.67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Val2054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57.91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la170 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n2055 [N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83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Pro35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6.09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sn2055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85.0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baseline="0" dirty="0" smtClean="0">
                          <a:solidFill>
                            <a:srgbClr val="007DDA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Gln174</a:t>
                      </a:r>
                      <a:r>
                        <a:rPr lang="en-US" sz="800" b="0" dirty="0" smtClean="0">
                          <a:solidFill>
                            <a:srgbClr val="0070C0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 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[O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n2055 [N</a:t>
                      </a:r>
                      <a:r>
                        <a:rPr lang="el-GR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δ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3.27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Tyr39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33.5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Thr205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0.00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  <a:tr h="155448"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n271 [O</a:t>
                      </a:r>
                      <a:r>
                        <a:rPr lang="el-GR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δ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1]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Asn2055 [N</a:t>
                      </a:r>
                      <a:r>
                        <a:rPr lang="el-GR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δ</a:t>
                      </a:r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]</a:t>
                      </a:r>
                      <a:endParaRPr lang="en-CA" sz="800" b="0" dirty="0" smtClean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0" dirty="0" smtClean="0">
                          <a:solidFill>
                            <a:schemeClr val="tx1"/>
                          </a:solidFill>
                          <a:latin typeface="Times New Roman" pitchFamily="18" charset="0"/>
                          <a:cs typeface="Times New Roman" pitchFamily="18" charset="0"/>
                        </a:rPr>
                        <a:t>2.94</a:t>
                      </a:r>
                      <a:endParaRPr lang="en-CA" sz="800" b="0" dirty="0">
                        <a:solidFill>
                          <a:schemeClr val="tx1"/>
                        </a:solidFill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Ala2057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solidFill>
                      <a:schemeClr val="bg1">
                        <a:lumMod val="8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47.96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solidFill>
                      <a:schemeClr val="bg1">
                        <a:lumMod val="85000"/>
                      </a:schemeClr>
                    </a:solidFill>
                  </a:tcPr>
                </a:tc>
              </a:tr>
              <a:tr h="155448">
                <a:tc gridSpan="3">
                  <a:txBody>
                    <a:bodyPr/>
                    <a:lstStyle/>
                    <a:p>
                      <a:pPr algn="ctr"/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A" sz="8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en-CA" sz="800" dirty="0">
                        <a:latin typeface="Arial" pitchFamily="34" charset="0"/>
                        <a:cs typeface="Arial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Leu205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 smtClean="0">
                          <a:latin typeface="Times New Roman" pitchFamily="18" charset="0"/>
                          <a:cs typeface="Times New Roman" pitchFamily="18" charset="0"/>
                        </a:rPr>
                        <a:t>94.78</a:t>
                      </a:r>
                      <a:endParaRPr lang="en-CA" sz="800" dirty="0"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0" marR="0" marT="0" marB="0" anchor="ctr"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noFill/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521</TotalTime>
  <Words>409</Words>
  <Application>Microsoft Office PowerPoint</Application>
  <PresentationFormat>Format US (216 x 279 mm)</PresentationFormat>
  <Paragraphs>203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Office Theme</vt:lpstr>
      <vt:lpstr>Diapositive 1</vt:lpstr>
    </vt:vector>
  </TitlesOfParts>
  <Company>Grizli777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elle</dc:creator>
  <cp:lastModifiedBy>Maryse</cp:lastModifiedBy>
  <cp:revision>430</cp:revision>
  <cp:lastPrinted>2011-06-14T08:21:48Z</cp:lastPrinted>
  <dcterms:created xsi:type="dcterms:W3CDTF">2011-06-14T08:21:34Z</dcterms:created>
  <dcterms:modified xsi:type="dcterms:W3CDTF">2012-05-10T12:23:02Z</dcterms:modified>
</cp:coreProperties>
</file>